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ct" ContentType="image/x-pict"/>
  <Override PartName="/ppt/media/image2.pct" ContentType="image/x-pict"/>
  <Override PartName="/ppt/media/image3.pct" ContentType="image/x-pict"/>
  <Override PartName="/ppt/media/image4.pct" ContentType="image/x-pict"/>
  <Override PartName="/ppt/media/image5.pct" ContentType="image/x-pict"/>
  <Override PartName="/ppt/media/image6.pct" ContentType="image/x-pict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10C771-58AF-40A1-9B3A-16DC7D72484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639520"/>
            <a:ext cx="5829120" cy="2617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506200"/>
            <a:ext cx="5829120" cy="2617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482F2D-3540-477F-96E9-5377855A62E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639520"/>
            <a:ext cx="2844360" cy="2617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639520"/>
            <a:ext cx="2844360" cy="2617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506200"/>
            <a:ext cx="2844360" cy="2617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506200"/>
            <a:ext cx="2844360" cy="2617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F89D6C-8E0C-4DCA-854B-427C580C4B9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639520"/>
            <a:ext cx="1876680" cy="2617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639520"/>
            <a:ext cx="1876680" cy="2617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639520"/>
            <a:ext cx="1876680" cy="2617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506200"/>
            <a:ext cx="1876680" cy="2617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506200"/>
            <a:ext cx="1876680" cy="2617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506200"/>
            <a:ext cx="1876680" cy="2617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0FC9B7-E83E-4E5A-96C8-DA2858CD756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639520"/>
            <a:ext cx="5829120" cy="5488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EE4531-4422-4466-890D-E2D7DB27843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639520"/>
            <a:ext cx="5829120" cy="54882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BAB910-EEDD-4146-9819-AA0CB17FAB7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639520"/>
            <a:ext cx="2844360" cy="54882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639520"/>
            <a:ext cx="2844360" cy="54882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5189C1-5956-47D3-8533-6277CDBB727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FEEB32-0E9A-4F4F-B5B6-11E092FC255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12520"/>
            <a:ext cx="58291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BEDFBF-FC89-4791-8CF8-8BBF4FA8097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639520"/>
            <a:ext cx="2844360" cy="2617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639520"/>
            <a:ext cx="2844360" cy="54882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506200"/>
            <a:ext cx="2844360" cy="2617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F201CF-B26C-42AD-B44F-07DCC064E29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639520"/>
            <a:ext cx="2844360" cy="54882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639520"/>
            <a:ext cx="2844360" cy="2617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506200"/>
            <a:ext cx="2844360" cy="2617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022377-6329-43A3-BABC-2A16F774DB0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639520"/>
            <a:ext cx="2844360" cy="2617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639520"/>
            <a:ext cx="2844360" cy="2617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506200"/>
            <a:ext cx="5829120" cy="2617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3EE3D1-06E9-4E7C-9FA3-13C301B0C23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639520"/>
            <a:ext cx="5829120" cy="54882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5960" indent="-22716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5960" indent="-22716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5960" indent="-22716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28840" cy="6098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31120"/>
            <a:ext cx="2171520" cy="6098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5E53C35-7B11-4AF4-B759-2D643EC751D5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ct"/><Relationship Id="rId2" Type="http://schemas.openxmlformats.org/officeDocument/2006/relationships/image" Target="../media/image2.pct"/><Relationship Id="rId3" Type="http://schemas.openxmlformats.org/officeDocument/2006/relationships/image" Target="../media/image3.pct"/><Relationship Id="rId4" Type="http://schemas.openxmlformats.org/officeDocument/2006/relationships/image" Target="../media/image4.pct"/><Relationship Id="rId5" Type="http://schemas.openxmlformats.org/officeDocument/2006/relationships/image" Target="../media/image5.pct"/><Relationship Id="rId6" Type="http://schemas.openxmlformats.org/officeDocument/2006/relationships/image" Target="../media/image6.pct"/><Relationship Id="rId7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2281320" y="2370240"/>
            <a:ext cx="865080" cy="260280"/>
          </a:xfrm>
          <a:prstGeom prst="rect">
            <a:avLst/>
          </a:prstGeom>
          <a:ln w="0">
            <a:noFill/>
          </a:ln>
        </p:spPr>
      </p:pic>
      <p:pic>
        <p:nvPicPr>
          <p:cNvPr id="42" name="" descr=""/>
          <p:cNvPicPr/>
          <p:nvPr/>
        </p:nvPicPr>
        <p:blipFill>
          <a:blip r:embed="rId2"/>
          <a:stretch/>
        </p:blipFill>
        <p:spPr>
          <a:xfrm>
            <a:off x="2281320" y="2073240"/>
            <a:ext cx="863640" cy="268200"/>
          </a:xfrm>
          <a:prstGeom prst="rect">
            <a:avLst/>
          </a:prstGeom>
          <a:ln w="0">
            <a:noFill/>
          </a:ln>
        </p:spPr>
      </p:pic>
      <p:pic>
        <p:nvPicPr>
          <p:cNvPr id="43" name="" descr=""/>
          <p:cNvPicPr/>
          <p:nvPr/>
        </p:nvPicPr>
        <p:blipFill>
          <a:blip r:embed="rId3"/>
          <a:stretch/>
        </p:blipFill>
        <p:spPr>
          <a:xfrm>
            <a:off x="2287440" y="1822320"/>
            <a:ext cx="857520" cy="216000"/>
          </a:xfrm>
          <a:prstGeom prst="rect">
            <a:avLst/>
          </a:prstGeom>
          <a:ln w="0">
            <a:noFill/>
          </a:ln>
        </p:spPr>
      </p:pic>
      <p:pic>
        <p:nvPicPr>
          <p:cNvPr id="44" name="" descr=""/>
          <p:cNvPicPr/>
          <p:nvPr/>
        </p:nvPicPr>
        <p:blipFill>
          <a:blip r:embed="rId4"/>
          <a:stretch/>
        </p:blipFill>
        <p:spPr>
          <a:xfrm>
            <a:off x="3201840" y="2079720"/>
            <a:ext cx="857520" cy="258840"/>
          </a:xfrm>
          <a:prstGeom prst="rect">
            <a:avLst/>
          </a:prstGeom>
          <a:ln w="0">
            <a:noFill/>
          </a:ln>
        </p:spPr>
      </p:pic>
      <p:sp>
        <p:nvSpPr>
          <p:cNvPr id="45" name=""/>
          <p:cNvSpPr/>
          <p:nvPr/>
        </p:nvSpPr>
        <p:spPr>
          <a:xfrm>
            <a:off x="1451520" y="1747800"/>
            <a:ext cx="884880" cy="88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8760" rIns="68760" tIns="34200" bIns="34200" anchor="t">
            <a:spAutoFit/>
          </a:bodyPr>
          <a:p>
            <a:pPr algn="r">
              <a:lnSpc>
                <a:spcPct val="150000"/>
              </a:lnSpc>
              <a:tabLst>
                <a:tab algn="l" pos="0"/>
                <a:tab algn="l" pos="687240"/>
                <a:tab algn="l" pos="1374840"/>
                <a:tab algn="l" pos="2062080"/>
                <a:tab algn="l" pos="2749680"/>
                <a:tab algn="l" pos="3436920"/>
                <a:tab algn="l" pos="4124160"/>
                <a:tab algn="l" pos="4811760"/>
                <a:tab algn="l" pos="5499000"/>
                <a:tab algn="l" pos="6186600"/>
                <a:tab algn="l" pos="6873840"/>
                <a:tab algn="l" pos="7561440"/>
                <a:tab algn="l" pos="8248680"/>
                <a:tab algn="l" pos="8935920"/>
                <a:tab algn="l" pos="9623520"/>
                <a:tab algn="l" pos="1031076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Integrin 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50000"/>
              </a:lnSpc>
              <a:tabLst>
                <a:tab algn="l" pos="0"/>
                <a:tab algn="l" pos="687240"/>
                <a:tab algn="l" pos="1374840"/>
                <a:tab algn="l" pos="2062080"/>
                <a:tab algn="l" pos="2749680"/>
                <a:tab algn="l" pos="3436920"/>
                <a:tab algn="l" pos="4124160"/>
                <a:tab algn="l" pos="4811760"/>
                <a:tab algn="l" pos="5499000"/>
                <a:tab algn="l" pos="6186600"/>
                <a:tab algn="l" pos="6873840"/>
                <a:tab algn="l" pos="7561440"/>
                <a:tab algn="l" pos="8248680"/>
                <a:tab algn="l" pos="8935920"/>
                <a:tab algn="l" pos="9623520"/>
                <a:tab algn="l" pos="1031076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N-cadher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50000"/>
              </a:lnSpc>
              <a:tabLst>
                <a:tab algn="l" pos="0"/>
                <a:tab algn="l" pos="687240"/>
                <a:tab algn="l" pos="1374840"/>
                <a:tab algn="l" pos="2062080"/>
                <a:tab algn="l" pos="2749680"/>
                <a:tab algn="l" pos="3436920"/>
                <a:tab algn="l" pos="4124160"/>
                <a:tab algn="l" pos="4811760"/>
                <a:tab algn="l" pos="5499000"/>
                <a:tab algn="l" pos="6186600"/>
                <a:tab algn="l" pos="6873840"/>
                <a:tab algn="l" pos="7561440"/>
                <a:tab algn="l" pos="8248680"/>
                <a:tab algn="l" pos="8935920"/>
                <a:tab algn="l" pos="9623520"/>
                <a:tab algn="l" pos="1031076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Tubul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6" name="" descr=""/>
          <p:cNvPicPr/>
          <p:nvPr/>
        </p:nvPicPr>
        <p:blipFill>
          <a:blip r:embed="rId5"/>
          <a:stretch/>
        </p:blipFill>
        <p:spPr>
          <a:xfrm>
            <a:off x="3201840" y="2368440"/>
            <a:ext cx="857520" cy="260640"/>
          </a:xfrm>
          <a:prstGeom prst="rect">
            <a:avLst/>
          </a:prstGeom>
          <a:ln w="0">
            <a:noFill/>
          </a:ln>
        </p:spPr>
      </p:pic>
      <p:sp>
        <p:nvSpPr>
          <p:cNvPr id="47" name=""/>
          <p:cNvSpPr/>
          <p:nvPr/>
        </p:nvSpPr>
        <p:spPr>
          <a:xfrm>
            <a:off x="2285280" y="1511280"/>
            <a:ext cx="1674360" cy="251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8760" rIns="68760" tIns="34200" bIns="34200" anchor="t">
            <a:spAutoFit/>
          </a:bodyPr>
          <a:p>
            <a:pPr>
              <a:tabLst>
                <a:tab algn="l" pos="0"/>
                <a:tab algn="l" pos="687240"/>
                <a:tab algn="l" pos="1374840"/>
                <a:tab algn="l" pos="2062080"/>
                <a:tab algn="l" pos="2749680"/>
                <a:tab algn="l" pos="3436920"/>
                <a:tab algn="l" pos="4124160"/>
                <a:tab algn="l" pos="4811760"/>
                <a:tab algn="l" pos="5499000"/>
                <a:tab algn="l" pos="6186600"/>
                <a:tab algn="l" pos="6873840"/>
                <a:tab algn="l" pos="7561440"/>
                <a:tab algn="l" pos="8248680"/>
                <a:tab algn="l" pos="8935920"/>
                <a:tab algn="l" pos="9623520"/>
                <a:tab algn="l" pos="1031076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U-87 MG     U-251 M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8" name="" descr=""/>
          <p:cNvPicPr/>
          <p:nvPr/>
        </p:nvPicPr>
        <p:blipFill>
          <a:blip r:embed="rId6"/>
          <a:stretch/>
        </p:blipFill>
        <p:spPr>
          <a:xfrm>
            <a:off x="3192480" y="1824120"/>
            <a:ext cx="873000" cy="217440"/>
          </a:xfrm>
          <a:prstGeom prst="rect">
            <a:avLst/>
          </a:prstGeom>
          <a:ln w="0">
            <a:noFill/>
          </a:ln>
        </p:spPr>
      </p:pic>
      <p:sp>
        <p:nvSpPr>
          <p:cNvPr id="49" name=""/>
          <p:cNvSpPr/>
          <p:nvPr/>
        </p:nvSpPr>
        <p:spPr>
          <a:xfrm>
            <a:off x="743040" y="3986280"/>
            <a:ext cx="5373720" cy="480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8760" rIns="68760" tIns="34200" bIns="34200" anchor="t">
            <a:spAutoFit/>
          </a:bodyPr>
          <a:p>
            <a:pPr>
              <a:lnSpc>
                <a:spcPct val="100000"/>
              </a:lnSpc>
              <a:spcBef>
                <a:spcPts val="561"/>
              </a:spcBef>
              <a:tabLst>
                <a:tab algn="l" pos="0"/>
                <a:tab algn="l" pos="687240"/>
                <a:tab algn="l" pos="1374840"/>
                <a:tab algn="l" pos="2062080"/>
                <a:tab algn="l" pos="2749680"/>
                <a:tab algn="l" pos="3436920"/>
                <a:tab algn="l" pos="4124160"/>
                <a:tab algn="l" pos="4811760"/>
                <a:tab algn="l" pos="5499000"/>
                <a:tab algn="l" pos="6186600"/>
                <a:tab algn="l" pos="6873840"/>
                <a:tab algn="l" pos="7561440"/>
                <a:tab algn="l" pos="8248680"/>
                <a:tab algn="l" pos="8935920"/>
                <a:tab algn="l" pos="9623520"/>
                <a:tab algn="l" pos="1031076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</a:rPr>
              <a:t>Supplemental Figure 1.</a:t>
            </a: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 Tie2-mediated modulation of adhesive molecules in gliomas at protein levels. Western blotting analysis of U-87 MG cells treated with Ang1 or vehicle and of U251.vector and U251.Tie2 showing the expression level of N-cadherin and Integrin </a:t>
            </a:r>
            <a:r>
              <a:rPr b="0" lang="en-US" sz="9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1. Tubulin is shown as loading control.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1446120" y="2708280"/>
            <a:ext cx="2727360" cy="236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8760" rIns="68760" tIns="34200" bIns="342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687240"/>
                <a:tab algn="l" pos="1374840"/>
                <a:tab algn="l" pos="2062080"/>
                <a:tab algn="l" pos="2749680"/>
                <a:tab algn="l" pos="3436920"/>
                <a:tab algn="l" pos="4124160"/>
                <a:tab algn="l" pos="4811760"/>
                <a:tab algn="l" pos="5499000"/>
                <a:tab algn="l" pos="6186600"/>
                <a:tab algn="l" pos="6873840"/>
                <a:tab algn="l" pos="7561440"/>
                <a:tab algn="l" pos="8248680"/>
                <a:tab algn="l" pos="8935920"/>
                <a:tab algn="l" pos="9623520"/>
                <a:tab algn="l" pos="1031076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Tie2 activation:   -        +            -         +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4573440" y="533520"/>
            <a:ext cx="1714680" cy="236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8760" rIns="68760" tIns="34200" bIns="34200" anchor="t">
            <a:spAutoFit/>
          </a:bodyPr>
          <a:p>
            <a:pPr>
              <a:tabLst>
                <a:tab algn="l" pos="0"/>
                <a:tab algn="l" pos="687240"/>
                <a:tab algn="l" pos="1374840"/>
                <a:tab algn="l" pos="2062080"/>
                <a:tab algn="l" pos="2749680"/>
                <a:tab algn="l" pos="3436920"/>
                <a:tab algn="l" pos="4124160"/>
                <a:tab algn="l" pos="4811760"/>
                <a:tab algn="l" pos="5499000"/>
                <a:tab algn="l" pos="6186600"/>
                <a:tab algn="l" pos="6873840"/>
                <a:tab algn="l" pos="7561440"/>
                <a:tab algn="l" pos="8248680"/>
                <a:tab algn="l" pos="8935920"/>
                <a:tab algn="l" pos="9623520"/>
                <a:tab algn="l" pos="1031076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Supplemental Figure 1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7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2-15T17:17:56Z</dcterms:created>
  <dc:creator>MD Anderson Cancer Center</dc:creator>
  <dc:description/>
  <dc:language>en-US</dc:language>
  <cp:lastModifiedBy>MD Anderson Cancer Center</cp:lastModifiedBy>
  <cp:lastPrinted>2010-10-08T17:58:47Z</cp:lastPrinted>
  <dcterms:modified xsi:type="dcterms:W3CDTF">2010-10-08T17:58:51Z</dcterms:modified>
  <cp:revision>7</cp:revision>
  <dc:subject/>
  <dc:title>PowerPoint Presentation</dc:title>
</cp:coreProperties>
</file>